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6"/>
  </p:normalViewPr>
  <p:slideViewPr>
    <p:cSldViewPr snapToGrid="0" snapToObjects="1">
      <p:cViewPr varScale="1">
        <p:scale>
          <a:sx n="121" d="100"/>
          <a:sy n="121" d="100"/>
        </p:scale>
        <p:origin x="20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wamuU/Dropbox/&#35542;&#25991;/RB+RA/RA+RB&#93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年代毎疾患偏移!$B$1</c:f>
              <c:strCache>
                <c:ptCount val="1"/>
                <c:pt idx="0">
                  <c:v>Period1</c:v>
                </c:pt>
              </c:strCache>
            </c:strRef>
          </c:tx>
          <c:spPr>
            <a:gradFill rotWithShape="1">
              <a:gsLst>
                <a:gs pos="0">
                  <a:schemeClr val="accent1">
                    <a:tint val="100000"/>
                    <a:shade val="100000"/>
                    <a:satMod val="13000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年代毎疾患偏移!$A$2:$A$16</c:f>
              <c:strCache>
                <c:ptCount val="15"/>
                <c:pt idx="0">
                  <c:v>MN(primary)</c:v>
                </c:pt>
                <c:pt idx="1">
                  <c:v>MN(gold)</c:v>
                </c:pt>
                <c:pt idx="2">
                  <c:v>MN(penicillamine)</c:v>
                </c:pt>
                <c:pt idx="3">
                  <c:v>MN(bucillamine)</c:v>
                </c:pt>
                <c:pt idx="4">
                  <c:v>AA-amyloid</c:v>
                </c:pt>
                <c:pt idx="5">
                  <c:v>IgAN</c:v>
                </c:pt>
                <c:pt idx="6">
                  <c:v>Nephrosclerosis</c:v>
                </c:pt>
                <c:pt idx="7">
                  <c:v>ANCA-GN</c:v>
                </c:pt>
                <c:pt idx="8">
                  <c:v>DN</c:v>
                </c:pt>
                <c:pt idx="9">
                  <c:v>MCNS</c:v>
                </c:pt>
                <c:pt idx="10">
                  <c:v>FGS</c:v>
                </c:pt>
                <c:pt idx="11">
                  <c:v>ANCA-negative GN</c:v>
                </c:pt>
                <c:pt idx="12">
                  <c:v>MPGN</c:v>
                </c:pt>
                <c:pt idx="13">
                  <c:v>IgA vasculitis</c:v>
                </c:pt>
                <c:pt idx="14">
                  <c:v>Others</c:v>
                </c:pt>
              </c:strCache>
            </c:strRef>
          </c:cat>
          <c:val>
            <c:numRef>
              <c:f>年代毎疾患偏移!$B$2:$B$16</c:f>
              <c:numCache>
                <c:formatCode>General</c:formatCode>
                <c:ptCount val="15"/>
                <c:pt idx="0">
                  <c:v>1</c:v>
                </c:pt>
                <c:pt idx="1">
                  <c:v>2</c:v>
                </c:pt>
                <c:pt idx="2">
                  <c:v>2</c:v>
                </c:pt>
                <c:pt idx="3">
                  <c:v>7</c:v>
                </c:pt>
                <c:pt idx="4">
                  <c:v>7</c:v>
                </c:pt>
                <c:pt idx="5">
                  <c:v>8</c:v>
                </c:pt>
                <c:pt idx="6">
                  <c:v>10</c:v>
                </c:pt>
                <c:pt idx="7">
                  <c:v>1</c:v>
                </c:pt>
                <c:pt idx="8">
                  <c:v>2</c:v>
                </c:pt>
                <c:pt idx="9">
                  <c:v>3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0</c:v>
                </c:pt>
                <c:pt idx="1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C0-0A49-8B20-1423A6AF3441}"/>
            </c:ext>
          </c:extLst>
        </c:ser>
        <c:ser>
          <c:idx val="1"/>
          <c:order val="1"/>
          <c:tx>
            <c:strRef>
              <c:f>年代毎疾患偏移!$C$1</c:f>
              <c:strCache>
                <c:ptCount val="1"/>
                <c:pt idx="0">
                  <c:v>Period2</c:v>
                </c:pt>
              </c:strCache>
            </c:strRef>
          </c:tx>
          <c:spPr>
            <a:gradFill rotWithShape="1">
              <a:gsLst>
                <a:gs pos="0">
                  <a:srgbClr val="FF0000"/>
                </a:gs>
                <a:gs pos="100000">
                  <a:srgbClr val="F48D90"/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dPt>
            <c:idx val="3"/>
            <c:invertIfNegative val="0"/>
            <c:bubble3D val="0"/>
            <c:spPr>
              <a:gradFill rotWithShape="1">
                <a:gsLst>
                  <a:gs pos="0">
                    <a:srgbClr val="FF0000"/>
                  </a:gs>
                  <a:gs pos="100000">
                    <a:srgbClr val="F48D90"/>
                  </a:gs>
                </a:gsLst>
                <a:lin ang="16200000" scaled="0"/>
              </a:gradFill>
              <a:ln>
                <a:noFill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threePt" dir="t">
                  <a:rot lat="0" lon="0" rev="1200000"/>
                </a:lightRig>
              </a:scene3d>
              <a:sp3d>
                <a:bevelT w="63500" h="25400"/>
              </a:sp3d>
            </c:spPr>
            <c:extLst>
              <c:ext xmlns:c16="http://schemas.microsoft.com/office/drawing/2014/chart" uri="{C3380CC4-5D6E-409C-BE32-E72D297353CC}">
                <c16:uniqueId val="{00000006-C8C0-0A49-8B20-1423A6AF344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年代毎疾患偏移!$A$2:$A$16</c:f>
              <c:strCache>
                <c:ptCount val="15"/>
                <c:pt idx="0">
                  <c:v>MN(primary)</c:v>
                </c:pt>
                <c:pt idx="1">
                  <c:v>MN(gold)</c:v>
                </c:pt>
                <c:pt idx="2">
                  <c:v>MN(penicillamine)</c:v>
                </c:pt>
                <c:pt idx="3">
                  <c:v>MN(bucillamine)</c:v>
                </c:pt>
                <c:pt idx="4">
                  <c:v>AA-amyloid</c:v>
                </c:pt>
                <c:pt idx="5">
                  <c:v>IgAN</c:v>
                </c:pt>
                <c:pt idx="6">
                  <c:v>Nephrosclerosis</c:v>
                </c:pt>
                <c:pt idx="7">
                  <c:v>ANCA-GN</c:v>
                </c:pt>
                <c:pt idx="8">
                  <c:v>DN</c:v>
                </c:pt>
                <c:pt idx="9">
                  <c:v>MCNS</c:v>
                </c:pt>
                <c:pt idx="10">
                  <c:v>FGS</c:v>
                </c:pt>
                <c:pt idx="11">
                  <c:v>ANCA-negative GN</c:v>
                </c:pt>
                <c:pt idx="12">
                  <c:v>MPGN</c:v>
                </c:pt>
                <c:pt idx="13">
                  <c:v>IgA vasculitis</c:v>
                </c:pt>
                <c:pt idx="14">
                  <c:v>Others</c:v>
                </c:pt>
              </c:strCache>
            </c:strRef>
          </c:cat>
          <c:val>
            <c:numRef>
              <c:f>年代毎疾患偏移!$C$2:$C$16</c:f>
              <c:numCache>
                <c:formatCode>General</c:formatCode>
                <c:ptCount val="15"/>
                <c:pt idx="0">
                  <c:v>4</c:v>
                </c:pt>
                <c:pt idx="1">
                  <c:v>0</c:v>
                </c:pt>
                <c:pt idx="2">
                  <c:v>1</c:v>
                </c:pt>
                <c:pt idx="3">
                  <c:v>19</c:v>
                </c:pt>
                <c:pt idx="4">
                  <c:v>10</c:v>
                </c:pt>
                <c:pt idx="5">
                  <c:v>5</c:v>
                </c:pt>
                <c:pt idx="6">
                  <c:v>2</c:v>
                </c:pt>
                <c:pt idx="7">
                  <c:v>4</c:v>
                </c:pt>
                <c:pt idx="8">
                  <c:v>2</c:v>
                </c:pt>
                <c:pt idx="9">
                  <c:v>2</c:v>
                </c:pt>
                <c:pt idx="10">
                  <c:v>3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C0-0A49-8B20-1423A6AF3441}"/>
            </c:ext>
          </c:extLst>
        </c:ser>
        <c:ser>
          <c:idx val="2"/>
          <c:order val="2"/>
          <c:tx>
            <c:strRef>
              <c:f>年代毎疾患偏移!$D$1</c:f>
              <c:strCache>
                <c:ptCount val="1"/>
                <c:pt idx="0">
                  <c:v>Period3</c:v>
                </c:pt>
              </c:strCache>
            </c:strRef>
          </c:tx>
          <c:spPr>
            <a:gradFill rotWithShape="1">
              <a:gsLst>
                <a:gs pos="0">
                  <a:srgbClr val="FFFF00"/>
                </a:gs>
                <a:gs pos="100000">
                  <a:schemeClr val="accent4">
                    <a:lumMod val="40000"/>
                    <a:lumOff val="60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  <a:scene3d>
              <a:camera prst="orthographicFront">
                <a:rot lat="0" lon="0" rev="0"/>
              </a:camera>
              <a:lightRig rig="threePt" dir="t">
                <a:rot lat="0" lon="0" rev="1200000"/>
              </a:lightRig>
            </a:scene3d>
            <a:sp3d>
              <a:bevelT w="63500" h="25400"/>
            </a:sp3d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年代毎疾患偏移!$A$2:$A$16</c:f>
              <c:strCache>
                <c:ptCount val="15"/>
                <c:pt idx="0">
                  <c:v>MN(primary)</c:v>
                </c:pt>
                <c:pt idx="1">
                  <c:v>MN(gold)</c:v>
                </c:pt>
                <c:pt idx="2">
                  <c:v>MN(penicillamine)</c:v>
                </c:pt>
                <c:pt idx="3">
                  <c:v>MN(bucillamine)</c:v>
                </c:pt>
                <c:pt idx="4">
                  <c:v>AA-amyloid</c:v>
                </c:pt>
                <c:pt idx="5">
                  <c:v>IgAN</c:v>
                </c:pt>
                <c:pt idx="6">
                  <c:v>Nephrosclerosis</c:v>
                </c:pt>
                <c:pt idx="7">
                  <c:v>ANCA-GN</c:v>
                </c:pt>
                <c:pt idx="8">
                  <c:v>DN</c:v>
                </c:pt>
                <c:pt idx="9">
                  <c:v>MCNS</c:v>
                </c:pt>
                <c:pt idx="10">
                  <c:v>FGS</c:v>
                </c:pt>
                <c:pt idx="11">
                  <c:v>ANCA-negative GN</c:v>
                </c:pt>
                <c:pt idx="12">
                  <c:v>MPGN</c:v>
                </c:pt>
                <c:pt idx="13">
                  <c:v>IgA vasculitis</c:v>
                </c:pt>
                <c:pt idx="14">
                  <c:v>Others</c:v>
                </c:pt>
              </c:strCache>
            </c:strRef>
          </c:cat>
          <c:val>
            <c:numRef>
              <c:f>年代毎疾患偏移!$D$2:$D$16</c:f>
              <c:numCache>
                <c:formatCode>General</c:formatCode>
                <c:ptCount val="15"/>
                <c:pt idx="0">
                  <c:v>4</c:v>
                </c:pt>
                <c:pt idx="1">
                  <c:v>0</c:v>
                </c:pt>
                <c:pt idx="2">
                  <c:v>0</c:v>
                </c:pt>
                <c:pt idx="3">
                  <c:v>8</c:v>
                </c:pt>
                <c:pt idx="4">
                  <c:v>4</c:v>
                </c:pt>
                <c:pt idx="5">
                  <c:v>4</c:v>
                </c:pt>
                <c:pt idx="6">
                  <c:v>10</c:v>
                </c:pt>
                <c:pt idx="7">
                  <c:v>5</c:v>
                </c:pt>
                <c:pt idx="8">
                  <c:v>6</c:v>
                </c:pt>
                <c:pt idx="9">
                  <c:v>1</c:v>
                </c:pt>
                <c:pt idx="10">
                  <c:v>1</c:v>
                </c:pt>
                <c:pt idx="11">
                  <c:v>3</c:v>
                </c:pt>
                <c:pt idx="12">
                  <c:v>2</c:v>
                </c:pt>
                <c:pt idx="13">
                  <c:v>1</c:v>
                </c:pt>
                <c:pt idx="14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8C0-0A49-8B20-1423A6AF3441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4"/>
        <c:axId val="452252303"/>
        <c:axId val="452253935"/>
      </c:barChart>
      <c:catAx>
        <c:axId val="4522523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52253935"/>
        <c:crosses val="autoZero"/>
        <c:auto val="1"/>
        <c:lblAlgn val="ctr"/>
        <c:lblOffset val="100"/>
        <c:noMultiLvlLbl val="0"/>
      </c:catAx>
      <c:valAx>
        <c:axId val="4522539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5225230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6689C7-1835-904D-8575-EE745C344B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2D5F75F-E30B-1342-BAFD-632D6F7C02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A21350-6016-F942-B095-B0EF4FD43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7B9AD6-7005-084E-B307-39BCD5062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16601C-4B61-E744-A772-F9CFA1F50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111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1BE007-463A-6946-AC7F-34645CA01C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335792C-5AC0-E94E-95B0-72F6CBDE3D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5ADC06-BBFE-A14E-8556-F30B6A450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EAE08D-6A09-DD47-8D3F-F102544CF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554559-16C2-3E43-9CCC-BB329D606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273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AE3EC35-E20B-094D-8F2B-FD82F4B43D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551598C-0026-ED43-96C1-87C2431237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B3BA7A-0076-BA40-8BD0-9B823CC6E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BF9052-B0DF-C544-BEFE-EDDB3549A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4687F44-F6BE-414E-BD2A-D3DF88C73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445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95DE94-84BC-B041-8131-89CF029937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E9E5B71-A334-DA45-8E58-F21DE04A26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61DEBE-9173-5D48-A1B6-5FACBB47D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60FB00-8AFC-9B41-A648-9DA44F960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F26724-745C-7148-9CD6-B251827042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49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4D7165-E183-B144-944A-5A502E031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81AE7F-D32B-DF49-BDDF-4FDF47D14F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522360-9F35-E542-A823-0E3907CC0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8D2D7F-6AF2-DA49-B73D-663E5A149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5720923-673C-0D4A-8D94-721ECF6EF7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096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BBCA6F-703C-D349-ADAC-D3DABB82EF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6062E02-1EAF-E74B-894F-5A395A0823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BEC8355-9B4E-3A42-97D4-203A19AB36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A5E4D1-EDC9-6D4B-85A5-F79E6D32E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9D96867-D7CA-A54B-87D6-52992A38E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CE67E61-D0AD-7041-9B0A-3DD1BE6A6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316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88D085-57B7-0743-A94A-1998A28B8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6588C0F-01F9-6C4E-A690-7BD499488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B8F9B1B-6A06-6C42-87F8-54EAEF6536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D136987-8624-2D45-8876-E3266B51B8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0E1EE3E-5B18-6849-8C9B-AE6888773A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B8E9F6B-8D9C-8A48-8972-CC708A8CC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C68C7D0-8E9E-8347-B1B2-0DDE1A10B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325267F-3686-8847-B501-A32ECF154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226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45604A-5C9A-D442-B4C1-8AEDC4DA0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D1D5A51-8849-0C41-A2F1-CDB8DFC76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CD29DE5-A491-104D-9D52-E7725AA73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B8566FE-B280-5A4F-85D0-25AB6F42F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6625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AD20654-539A-8E45-89A9-92FF6CC34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1B48C32-A048-354A-86FE-421498E5F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E30A463-3B76-574D-8149-ED2D61FEF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22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DB16DB-4AC4-E94B-8277-4831F4FA7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DB152A8-4ACC-4641-BCA4-C7B1729A7A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07A4B47-3F52-4B4E-82A1-F68D7D3C6B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C2A8DDB-69C7-0E4E-BBA6-FB9393D685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739DA3-7862-974A-9002-DC8125DBF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E3356DF-1E3A-3747-B75A-721AFBA7D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814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1E35B0-1488-7E45-B8CD-41F1F88D4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51BBFDA-F2FE-2145-9029-60D0106DEC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9822B85-C44A-1C4D-8CC9-A36CC21CDC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9C53DF5-A557-4A48-8427-C2F04D3EC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D032FD-3494-9E41-90FB-3CED18944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C12015-593B-F64A-A367-F4FCC0994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8538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0574359-4855-1347-8A6C-ED4C00672A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19EA84F-0DEB-514D-8EB9-9BA28C9B77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E20168-9092-D042-829D-D9CB16D2D5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16915-0402-A247-BC92-CD2BC8058DF1}" type="datetimeFigureOut">
              <a:rPr kumimoji="1" lang="ja-JP" altLang="en-US" smtClean="0"/>
              <a:t>2020/1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9B1F2A-4C24-2946-A158-2AC018394A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232581-148D-FF42-A0E4-BBD83F4CA1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423D49-8086-A94A-98E7-B2FEC53FD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2593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BB34999F-C493-C845-9EE5-71EF8AC26F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020227"/>
              </p:ext>
            </p:extLst>
          </p:nvPr>
        </p:nvGraphicFramePr>
        <p:xfrm>
          <a:off x="1085851" y="279400"/>
          <a:ext cx="10020299" cy="5930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8F95070-685F-D04E-86FF-32EFEC0C05D9}"/>
              </a:ext>
            </a:extLst>
          </p:cNvPr>
          <p:cNvSpPr txBox="1"/>
          <p:nvPr/>
        </p:nvSpPr>
        <p:spPr>
          <a:xfrm>
            <a:off x="4831872" y="6272085"/>
            <a:ext cx="2528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figure 1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221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善文 乳原</dc:creator>
  <cp:lastModifiedBy>澤村 昌人</cp:lastModifiedBy>
  <cp:revision>2</cp:revision>
  <dcterms:created xsi:type="dcterms:W3CDTF">2020-11-08T17:28:57Z</dcterms:created>
  <dcterms:modified xsi:type="dcterms:W3CDTF">2020-11-24T05:43:24Z</dcterms:modified>
</cp:coreProperties>
</file>